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3" autoAdjust="0"/>
    <p:restoredTop sz="94660"/>
  </p:normalViewPr>
  <p:slideViewPr>
    <p:cSldViewPr snapToGrid="0">
      <p:cViewPr varScale="1">
        <p:scale>
          <a:sx n="65" d="100"/>
          <a:sy n="65" d="100"/>
        </p:scale>
        <p:origin x="-2486" y="-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06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41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919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895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93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5959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92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096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649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184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297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7838B-AA10-4373-88FC-22B2010AA4B0}" type="datetimeFigureOut">
              <a:rPr lang="en-US" smtClean="0"/>
              <a:t>3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7C9F5-02F5-457C-BD64-48638BC67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4126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92935B67-A1AC-4821-9D64-F9729737D289}"/>
              </a:ext>
            </a:extLst>
          </p:cNvPr>
          <p:cNvGrpSpPr/>
          <p:nvPr/>
        </p:nvGrpSpPr>
        <p:grpSpPr>
          <a:xfrm>
            <a:off x="934777" y="1351514"/>
            <a:ext cx="4627667" cy="5276696"/>
            <a:chOff x="2490219" y="1581303"/>
            <a:chExt cx="4627667" cy="5276696"/>
          </a:xfrm>
        </p:grpSpPr>
        <p:pic>
          <p:nvPicPr>
            <p:cNvPr id="5" name="Picture 2" descr="Image result for greater mekong subregion map">
              <a:extLst>
                <a:ext uri="{FF2B5EF4-FFF2-40B4-BE49-F238E27FC236}">
                  <a16:creationId xmlns:a16="http://schemas.microsoft.com/office/drawing/2014/main" xmlns="" id="{7FCA509D-0066-4CD4-8BFB-031A45B98C1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30508" y="1581303"/>
              <a:ext cx="4487378" cy="52766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ECE0C8A5-244B-4A99-99D5-0A7F918F0AE1}"/>
                </a:ext>
              </a:extLst>
            </p:cNvPr>
            <p:cNvSpPr txBox="1"/>
            <p:nvPr/>
          </p:nvSpPr>
          <p:spPr>
            <a:xfrm>
              <a:off x="2490219" y="2691517"/>
              <a:ext cx="1693199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KACHIN </a:t>
              </a:r>
            </a:p>
            <a:p>
              <a:pPr algn="ctr"/>
              <a:endParaRPr lang="en-US" sz="1200" b="1" dirty="0"/>
            </a:p>
          </p:txBody>
        </p:sp>
        <p:sp>
          <p:nvSpPr>
            <p:cNvPr id="10" name="5-Point Star 19">
              <a:extLst>
                <a:ext uri="{FF2B5EF4-FFF2-40B4-BE49-F238E27FC236}">
                  <a16:creationId xmlns:a16="http://schemas.microsoft.com/office/drawing/2014/main" xmlns="" id="{D50A7E19-403F-4D8E-9F29-F79D7C72935D}"/>
                </a:ext>
              </a:extLst>
            </p:cNvPr>
            <p:cNvSpPr/>
            <p:nvPr/>
          </p:nvSpPr>
          <p:spPr>
            <a:xfrm>
              <a:off x="3599172" y="2574217"/>
              <a:ext cx="166646" cy="14849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5-Point Star 24">
              <a:extLst>
                <a:ext uri="{FF2B5EF4-FFF2-40B4-BE49-F238E27FC236}">
                  <a16:creationId xmlns:a16="http://schemas.microsoft.com/office/drawing/2014/main" xmlns="" id="{80523385-D115-4AC8-9A48-E82FA0798AC1}"/>
                </a:ext>
              </a:extLst>
            </p:cNvPr>
            <p:cNvSpPr/>
            <p:nvPr/>
          </p:nvSpPr>
          <p:spPr>
            <a:xfrm>
              <a:off x="3765818" y="4125378"/>
              <a:ext cx="166646" cy="148494"/>
            </a:xfrm>
            <a:prstGeom prst="star5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105277D-EB64-4D5E-AABF-75942647C719}"/>
              </a:ext>
            </a:extLst>
          </p:cNvPr>
          <p:cNvSpPr txBox="1"/>
          <p:nvPr/>
        </p:nvSpPr>
        <p:spPr>
          <a:xfrm>
            <a:off x="409326" y="7034465"/>
            <a:ext cx="6039348" cy="954107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1: Fig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ap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f GMS showing the two border regions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tars) where </a:t>
            </a:r>
            <a:r>
              <a:rPr lang="en-US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Plasmodium vivax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linical samples were collect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Modified fromhttps://hkmb.hktdc.com/en/1X0A2LSH/hktdc-research/Opportunities-in-Thailand%E2%80%99s-Logistics-Market).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87101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33</Words>
  <Application>Microsoft Office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i, Liwang</dc:creator>
  <cp:lastModifiedBy>Yaya</cp:lastModifiedBy>
  <cp:revision>7</cp:revision>
  <dcterms:created xsi:type="dcterms:W3CDTF">2019-09-25T12:18:15Z</dcterms:created>
  <dcterms:modified xsi:type="dcterms:W3CDTF">2020-03-27T00:04:31Z</dcterms:modified>
</cp:coreProperties>
</file>